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DADAF-1167-49CD-A7C0-3E01F82E55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7340F-6D4D-49C8-97D9-1B27D17D03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6D5BD-410D-420E-9CF1-AAD336787E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57CE78-35CF-4724-BC5E-474EAB41DE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ED386-C207-46AE-812D-06C1430A4D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4E656-9F77-4FCC-BD2D-320BDD8345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DC0693-513C-483A-96A3-2C552DE0AF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A0F35-CAB3-4252-B4E3-FCF2958449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F9CDB-846E-4BA4-8C91-D3AB9EAAD2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9D784-CA3B-4B96-B3CC-F8EB24FE31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C3A70-B4ED-4E5D-83CD-FF478AA57E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D3103-E24C-4900-ACAB-EDCFF071D6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6F9149-1201-41F8-BCC6-8E86E0399F35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phique 3" descr=""/>
          <p:cNvPicPr/>
          <p:nvPr/>
        </p:nvPicPr>
        <p:blipFill>
          <a:blip r:embed="rId1"/>
          <a:stretch/>
        </p:blipFill>
        <p:spPr>
          <a:xfrm>
            <a:off x="1620720" y="676440"/>
            <a:ext cx="3329280" cy="210312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1"/>
          <p:cNvSpPr/>
          <p:nvPr/>
        </p:nvSpPr>
        <p:spPr>
          <a:xfrm>
            <a:off x="907920" y="3203640"/>
            <a:ext cx="50421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: 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Linearity of MITF assay.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 Branched DNA analysis of RNA extracted from wild-type or B16-F10 tumor-bearing lungs to determine MITF mRNA expression level. Different volumes of lung extract (0.1; 0.5; 1 and 5 µl)</a:t>
            </a:r>
            <a:r>
              <a:rPr b="0" i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were analyzed, showing a good linearity of the assay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8T14:42:44Z</dcterms:created>
  <dc:creator>Valerie KEDINGER</dc:creator>
  <dc:description/>
  <dc:language>en-US</dc:language>
  <cp:lastModifiedBy>pe</cp:lastModifiedBy>
  <dcterms:modified xsi:type="dcterms:W3CDTF">2013-07-08T08:22:40Z</dcterms:modified>
  <cp:revision>2</cp:revision>
  <dc:subject/>
  <dc:title>Présentation PowerPoint</dc:title>
</cp:coreProperties>
</file>